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4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50" d="100"/>
          <a:sy n="50" d="100"/>
        </p:scale>
        <p:origin x="360" y="12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iam Schreiber" userId="5a452ff8-f189-44a9-9767-da59f69398bf" providerId="ADAL" clId="{6DE644DB-330E-4693-90BB-205BED76EB5D}"/>
    <pc:docChg chg="delSld">
      <pc:chgData name="Miriam Schreiber" userId="5a452ff8-f189-44a9-9767-da59f69398bf" providerId="ADAL" clId="{6DE644DB-330E-4693-90BB-205BED76EB5D}" dt="2022-06-09T09:46:54.188" v="0" actId="47"/>
      <pc:docMkLst>
        <pc:docMk/>
      </pc:docMkLst>
      <pc:sldChg chg="del">
        <pc:chgData name="Miriam Schreiber" userId="5a452ff8-f189-44a9-9767-da59f69398bf" providerId="ADAL" clId="{6DE644DB-330E-4693-90BB-205BED76EB5D}" dt="2022-06-09T09:46:54.188" v="0" actId="47"/>
        <pc:sldMkLst>
          <pc:docMk/>
          <pc:sldMk cId="184469466" sldId="256"/>
        </pc:sldMkLst>
      </pc:sldChg>
    </pc:docChg>
  </pc:docChgLst>
  <pc:docChgLst>
    <pc:chgData name="Miriam Schreiber" userId="5a452ff8-f189-44a9-9767-da59f69398bf" providerId="ADAL" clId="{98BC51E7-E201-48FC-B6FC-E633AF824265}"/>
    <pc:docChg chg="custSel modSld">
      <pc:chgData name="Miriam Schreiber" userId="5a452ff8-f189-44a9-9767-da59f69398bf" providerId="ADAL" clId="{98BC51E7-E201-48FC-B6FC-E633AF824265}" dt="2022-07-27T10:28:00.582" v="118" actId="2711"/>
      <pc:docMkLst>
        <pc:docMk/>
      </pc:docMkLst>
      <pc:sldChg chg="addSp modSp mod">
        <pc:chgData name="Miriam Schreiber" userId="5a452ff8-f189-44a9-9767-da59f69398bf" providerId="ADAL" clId="{98BC51E7-E201-48FC-B6FC-E633AF824265}" dt="2022-07-27T10:28:00.582" v="118" actId="2711"/>
        <pc:sldMkLst>
          <pc:docMk/>
          <pc:sldMk cId="2135488458" sldId="257"/>
        </pc:sldMkLst>
        <pc:spChg chg="add mod">
          <ac:chgData name="Miriam Schreiber" userId="5a452ff8-f189-44a9-9767-da59f69398bf" providerId="ADAL" clId="{98BC51E7-E201-48FC-B6FC-E633AF824265}" dt="2022-07-27T10:28:00.582" v="118" actId="2711"/>
          <ac:spMkLst>
            <pc:docMk/>
            <pc:sldMk cId="2135488458" sldId="257"/>
            <ac:spMk id="2" creationId="{733FAD9B-9AA6-0117-6F36-FB8B829B6D61}"/>
          </ac:spMkLst>
        </pc:spChg>
      </pc:sldChg>
    </pc:docChg>
  </pc:docChgLst>
  <pc:docChgLst>
    <pc:chgData name="Miriam Schreiber" userId="5a452ff8-f189-44a9-9767-da59f69398bf" providerId="ADAL" clId="{A7C712C2-6042-4F4E-869B-8BAF3B95E273}"/>
    <pc:docChg chg="custSel addSld delSld modSld">
      <pc:chgData name="Miriam Schreiber" userId="5a452ff8-f189-44a9-9767-da59f69398bf" providerId="ADAL" clId="{A7C712C2-6042-4F4E-869B-8BAF3B95E273}" dt="2022-05-01T18:11:02.485" v="64" actId="1076"/>
      <pc:docMkLst>
        <pc:docMk/>
      </pc:docMkLst>
      <pc:sldChg chg="new">
        <pc:chgData name="Miriam Schreiber" userId="5a452ff8-f189-44a9-9767-da59f69398bf" providerId="ADAL" clId="{A7C712C2-6042-4F4E-869B-8BAF3B95E273}" dt="2022-05-01T15:13:02.024" v="0" actId="680"/>
        <pc:sldMkLst>
          <pc:docMk/>
          <pc:sldMk cId="184469466" sldId="256"/>
        </pc:sldMkLst>
      </pc:sldChg>
      <pc:sldChg chg="addSp delSp modSp new mod">
        <pc:chgData name="Miriam Schreiber" userId="5a452ff8-f189-44a9-9767-da59f69398bf" providerId="ADAL" clId="{A7C712C2-6042-4F4E-869B-8BAF3B95E273}" dt="2022-05-01T17:36:48.846" v="63" actId="1076"/>
        <pc:sldMkLst>
          <pc:docMk/>
          <pc:sldMk cId="2135488458" sldId="257"/>
        </pc:sldMkLst>
        <pc:spChg chg="del">
          <ac:chgData name="Miriam Schreiber" userId="5a452ff8-f189-44a9-9767-da59f69398bf" providerId="ADAL" clId="{A7C712C2-6042-4F4E-869B-8BAF3B95E273}" dt="2022-05-01T17:36:16.753" v="59" actId="478"/>
          <ac:spMkLst>
            <pc:docMk/>
            <pc:sldMk cId="2135488458" sldId="257"/>
            <ac:spMk id="2" creationId="{9D08EFE6-369F-4F98-B2F9-8D4B0BF23009}"/>
          </ac:spMkLst>
        </pc:spChg>
        <pc:spChg chg="del">
          <ac:chgData name="Miriam Schreiber" userId="5a452ff8-f189-44a9-9767-da59f69398bf" providerId="ADAL" clId="{A7C712C2-6042-4F4E-869B-8BAF3B95E273}" dt="2022-05-01T17:36:15.443" v="58" actId="478"/>
          <ac:spMkLst>
            <pc:docMk/>
            <pc:sldMk cId="2135488458" sldId="257"/>
            <ac:spMk id="3" creationId="{F5323D1F-F1F7-4DA8-B05D-89C41D0B8289}"/>
          </ac:spMkLst>
        </pc:spChg>
        <pc:graphicFrameChg chg="add mod">
          <ac:chgData name="Miriam Schreiber" userId="5a452ff8-f189-44a9-9767-da59f69398bf" providerId="ADAL" clId="{A7C712C2-6042-4F4E-869B-8BAF3B95E273}" dt="2022-05-01T17:36:20.490" v="60" actId="1076"/>
          <ac:graphicFrameMkLst>
            <pc:docMk/>
            <pc:sldMk cId="2135488458" sldId="257"/>
            <ac:graphicFrameMk id="4" creationId="{4C07B1E3-CABC-4822-9EAD-C7CEC73DC9E5}"/>
          </ac:graphicFrameMkLst>
        </pc:graphicFrameChg>
        <pc:graphicFrameChg chg="add mod">
          <ac:chgData name="Miriam Schreiber" userId="5a452ff8-f189-44a9-9767-da59f69398bf" providerId="ADAL" clId="{A7C712C2-6042-4F4E-869B-8BAF3B95E273}" dt="2022-05-01T17:36:48.846" v="63" actId="1076"/>
          <ac:graphicFrameMkLst>
            <pc:docMk/>
            <pc:sldMk cId="2135488458" sldId="257"/>
            <ac:graphicFrameMk id="5" creationId="{4C07B1E3-CABC-4822-9EAD-C7CEC73DC9E5}"/>
          </ac:graphicFrameMkLst>
        </pc:graphicFrameChg>
      </pc:sldChg>
      <pc:sldChg chg="addSp delSp modSp new mod">
        <pc:chgData name="Miriam Schreiber" userId="5a452ff8-f189-44a9-9767-da59f69398bf" providerId="ADAL" clId="{A7C712C2-6042-4F4E-869B-8BAF3B95E273}" dt="2022-05-01T17:34:26.402" v="52" actId="1076"/>
        <pc:sldMkLst>
          <pc:docMk/>
          <pc:sldMk cId="95698158" sldId="258"/>
        </pc:sldMkLst>
        <pc:spChg chg="del">
          <ac:chgData name="Miriam Schreiber" userId="5a452ff8-f189-44a9-9767-da59f69398bf" providerId="ADAL" clId="{A7C712C2-6042-4F4E-869B-8BAF3B95E273}" dt="2022-05-01T15:43:04.261" v="24" actId="478"/>
          <ac:spMkLst>
            <pc:docMk/>
            <pc:sldMk cId="95698158" sldId="258"/>
            <ac:spMk id="2" creationId="{347911D0-D7BD-495B-BC37-BBCC74FD4F99}"/>
          </ac:spMkLst>
        </pc:spChg>
        <pc:spChg chg="del">
          <ac:chgData name="Miriam Schreiber" userId="5a452ff8-f189-44a9-9767-da59f69398bf" providerId="ADAL" clId="{A7C712C2-6042-4F4E-869B-8BAF3B95E273}" dt="2022-05-01T15:43:06.398" v="25" actId="478"/>
          <ac:spMkLst>
            <pc:docMk/>
            <pc:sldMk cId="95698158" sldId="258"/>
            <ac:spMk id="3" creationId="{FB0BEE40-F2A2-40C0-B9C5-5EED214D82FB}"/>
          </ac:spMkLst>
        </pc:spChg>
        <pc:graphicFrameChg chg="add del mod">
          <ac:chgData name="Miriam Schreiber" userId="5a452ff8-f189-44a9-9767-da59f69398bf" providerId="ADAL" clId="{A7C712C2-6042-4F4E-869B-8BAF3B95E273}" dt="2022-05-01T15:44:01.445" v="32" actId="478"/>
          <ac:graphicFrameMkLst>
            <pc:docMk/>
            <pc:sldMk cId="95698158" sldId="258"/>
            <ac:graphicFrameMk id="4" creationId="{4C07B1E3-CABC-4822-9EAD-C7CEC73DC9E5}"/>
          </ac:graphicFrameMkLst>
        </pc:graphicFrameChg>
        <pc:graphicFrameChg chg="add del mod">
          <ac:chgData name="Miriam Schreiber" userId="5a452ff8-f189-44a9-9767-da59f69398bf" providerId="ADAL" clId="{A7C712C2-6042-4F4E-869B-8BAF3B95E273}" dt="2022-05-01T15:44:02.698" v="33" actId="478"/>
          <ac:graphicFrameMkLst>
            <pc:docMk/>
            <pc:sldMk cId="95698158" sldId="258"/>
            <ac:graphicFrameMk id="5" creationId="{4C07B1E3-CABC-4822-9EAD-C7CEC73DC9E5}"/>
          </ac:graphicFrameMkLst>
        </pc:graphicFrameChg>
        <pc:graphicFrameChg chg="add del mod">
          <ac:chgData name="Miriam Schreiber" userId="5a452ff8-f189-44a9-9767-da59f69398bf" providerId="ADAL" clId="{A7C712C2-6042-4F4E-869B-8BAF3B95E273}" dt="2022-05-01T17:32:53.003" v="38" actId="21"/>
          <ac:graphicFrameMkLst>
            <pc:docMk/>
            <pc:sldMk cId="95698158" sldId="258"/>
            <ac:graphicFrameMk id="6" creationId="{4C07B1E3-CABC-4822-9EAD-C7CEC73DC9E5}"/>
          </ac:graphicFrameMkLst>
        </pc:graphicFrameChg>
        <pc:graphicFrameChg chg="add mod">
          <ac:chgData name="Miriam Schreiber" userId="5a452ff8-f189-44a9-9767-da59f69398bf" providerId="ADAL" clId="{A7C712C2-6042-4F4E-869B-8BAF3B95E273}" dt="2022-05-01T17:34:26.402" v="52" actId="1076"/>
          <ac:graphicFrameMkLst>
            <pc:docMk/>
            <pc:sldMk cId="95698158" sldId="258"/>
            <ac:graphicFrameMk id="7" creationId="{4C07B1E3-CABC-4822-9EAD-C7CEC73DC9E5}"/>
          </ac:graphicFrameMkLst>
        </pc:graphicFrameChg>
        <pc:graphicFrameChg chg="add mod">
          <ac:chgData name="Miriam Schreiber" userId="5a452ff8-f189-44a9-9767-da59f69398bf" providerId="ADAL" clId="{A7C712C2-6042-4F4E-869B-8BAF3B95E273}" dt="2022-05-01T17:34:22.658" v="51" actId="1076"/>
          <ac:graphicFrameMkLst>
            <pc:docMk/>
            <pc:sldMk cId="95698158" sldId="258"/>
            <ac:graphicFrameMk id="8" creationId="{4C07B1E3-CABC-4822-9EAD-C7CEC73DC9E5}"/>
          </ac:graphicFrameMkLst>
        </pc:graphicFrameChg>
      </pc:sldChg>
      <pc:sldChg chg="addSp delSp modSp new mod">
        <pc:chgData name="Miriam Schreiber" userId="5a452ff8-f189-44a9-9767-da59f69398bf" providerId="ADAL" clId="{A7C712C2-6042-4F4E-869B-8BAF3B95E273}" dt="2022-05-01T18:11:02.485" v="64" actId="1076"/>
        <pc:sldMkLst>
          <pc:docMk/>
          <pc:sldMk cId="1409564746" sldId="259"/>
        </pc:sldMkLst>
        <pc:spChg chg="del">
          <ac:chgData name="Miriam Schreiber" userId="5a452ff8-f189-44a9-9767-da59f69398bf" providerId="ADAL" clId="{A7C712C2-6042-4F4E-869B-8BAF3B95E273}" dt="2022-05-01T15:41:01.693" v="18" actId="478"/>
          <ac:spMkLst>
            <pc:docMk/>
            <pc:sldMk cId="1409564746" sldId="259"/>
            <ac:spMk id="2" creationId="{148BB228-4989-47AE-BD81-9F8C7B330081}"/>
          </ac:spMkLst>
        </pc:spChg>
        <pc:spChg chg="del">
          <ac:chgData name="Miriam Schreiber" userId="5a452ff8-f189-44a9-9767-da59f69398bf" providerId="ADAL" clId="{A7C712C2-6042-4F4E-869B-8BAF3B95E273}" dt="2022-05-01T15:40:59.283" v="17" actId="478"/>
          <ac:spMkLst>
            <pc:docMk/>
            <pc:sldMk cId="1409564746" sldId="259"/>
            <ac:spMk id="3" creationId="{4F8258A0-91D1-469B-9E3C-6DCEC4686D1B}"/>
          </ac:spMkLst>
        </pc:spChg>
        <pc:graphicFrameChg chg="add mod">
          <ac:chgData name="Miriam Schreiber" userId="5a452ff8-f189-44a9-9767-da59f69398bf" providerId="ADAL" clId="{A7C712C2-6042-4F4E-869B-8BAF3B95E273}" dt="2022-05-01T18:11:02.485" v="64" actId="1076"/>
          <ac:graphicFrameMkLst>
            <pc:docMk/>
            <pc:sldMk cId="1409564746" sldId="259"/>
            <ac:graphicFrameMk id="4" creationId="{8FA6C339-2B1F-4D91-868C-C35983306334}"/>
          </ac:graphicFrameMkLst>
        </pc:graphicFrameChg>
      </pc:sldChg>
      <pc:sldChg chg="new del">
        <pc:chgData name="Miriam Schreiber" userId="5a452ff8-f189-44a9-9767-da59f69398bf" providerId="ADAL" clId="{A7C712C2-6042-4F4E-869B-8BAF3B95E273}" dt="2022-05-01T15:43:21.695" v="29" actId="47"/>
        <pc:sldMkLst>
          <pc:docMk/>
          <pc:sldMk cId="4293417909" sldId="260"/>
        </pc:sldMkLst>
      </pc:sldChg>
      <pc:sldChg chg="addSp delSp modSp new del mod">
        <pc:chgData name="Miriam Schreiber" userId="5a452ff8-f189-44a9-9767-da59f69398bf" providerId="ADAL" clId="{A7C712C2-6042-4F4E-869B-8BAF3B95E273}" dt="2022-05-01T15:43:21.695" v="29" actId="47"/>
        <pc:sldMkLst>
          <pc:docMk/>
          <pc:sldMk cId="966044151" sldId="261"/>
        </pc:sldMkLst>
        <pc:graphicFrameChg chg="add del mod">
          <ac:chgData name="Miriam Schreiber" userId="5a452ff8-f189-44a9-9767-da59f69398bf" providerId="ADAL" clId="{A7C712C2-6042-4F4E-869B-8BAF3B95E273}" dt="2022-05-01T15:40:48.162" v="13" actId="21"/>
          <ac:graphicFrameMkLst>
            <pc:docMk/>
            <pc:sldMk cId="966044151" sldId="261"/>
            <ac:graphicFrameMk id="6" creationId="{4C07B1E3-CABC-4822-9EAD-C7CEC73DC9E5}"/>
          </ac:graphicFrameMkLst>
        </pc:graphicFrameChg>
        <pc:picChg chg="add del">
          <ac:chgData name="Miriam Schreiber" userId="5a452ff8-f189-44a9-9767-da59f69398bf" providerId="ADAL" clId="{A7C712C2-6042-4F4E-869B-8BAF3B95E273}" dt="2022-05-01T15:40:37.099" v="9" actId="478"/>
          <ac:picMkLst>
            <pc:docMk/>
            <pc:sldMk cId="966044151" sldId="261"/>
            <ac:picMk id="5" creationId="{1DAC997F-D95E-4369-ACE8-CF3E5B6E3E22}"/>
          </ac:picMkLst>
        </pc:picChg>
      </pc:sldChg>
      <pc:sldChg chg="new del">
        <pc:chgData name="Miriam Schreiber" userId="5a452ff8-f189-44a9-9767-da59f69398bf" providerId="ADAL" clId="{A7C712C2-6042-4F4E-869B-8BAF3B95E273}" dt="2022-05-01T15:43:22.863" v="30" actId="47"/>
        <pc:sldMkLst>
          <pc:docMk/>
          <pc:sldMk cId="3239368634" sldId="262"/>
        </pc:sldMkLst>
      </pc:sldChg>
      <pc:sldChg chg="new del">
        <pc:chgData name="Miriam Schreiber" userId="5a452ff8-f189-44a9-9767-da59f69398bf" providerId="ADAL" clId="{A7C712C2-6042-4F4E-869B-8BAF3B95E273}" dt="2022-05-01T15:43:23.335" v="31" actId="47"/>
        <pc:sldMkLst>
          <pc:docMk/>
          <pc:sldMk cId="131139947" sldId="263"/>
        </pc:sldMkLst>
      </pc:sldChg>
      <pc:sldChg chg="addSp delSp modSp new mod">
        <pc:chgData name="Miriam Schreiber" userId="5a452ff8-f189-44a9-9767-da59f69398bf" providerId="ADAL" clId="{A7C712C2-6042-4F4E-869B-8BAF3B95E273}" dt="2022-05-01T17:35:30.562" v="55" actId="1076"/>
        <pc:sldMkLst>
          <pc:docMk/>
          <pc:sldMk cId="3186632296" sldId="264"/>
        </pc:sldMkLst>
        <pc:spChg chg="del">
          <ac:chgData name="Miriam Schreiber" userId="5a452ff8-f189-44a9-9767-da59f69398bf" providerId="ADAL" clId="{A7C712C2-6042-4F4E-869B-8BAF3B95E273}" dt="2022-05-01T17:32:58.566" v="42" actId="478"/>
          <ac:spMkLst>
            <pc:docMk/>
            <pc:sldMk cId="3186632296" sldId="264"/>
            <ac:spMk id="2" creationId="{186D9010-1A06-4AFE-9E81-08DD82CE61B4}"/>
          </ac:spMkLst>
        </pc:spChg>
        <pc:spChg chg="del">
          <ac:chgData name="Miriam Schreiber" userId="5a452ff8-f189-44a9-9767-da59f69398bf" providerId="ADAL" clId="{A7C712C2-6042-4F4E-869B-8BAF3B95E273}" dt="2022-05-01T17:32:57.298" v="41" actId="478"/>
          <ac:spMkLst>
            <pc:docMk/>
            <pc:sldMk cId="3186632296" sldId="264"/>
            <ac:spMk id="3" creationId="{D022DCCC-126B-48AB-ADF3-6E35673ACC6A}"/>
          </ac:spMkLst>
        </pc:spChg>
        <pc:graphicFrameChg chg="add mod">
          <ac:chgData name="Miriam Schreiber" userId="5a452ff8-f189-44a9-9767-da59f69398bf" providerId="ADAL" clId="{A7C712C2-6042-4F4E-869B-8BAF3B95E273}" dt="2022-05-01T17:33:01.836" v="43" actId="1076"/>
          <ac:graphicFrameMkLst>
            <pc:docMk/>
            <pc:sldMk cId="3186632296" sldId="264"/>
            <ac:graphicFrameMk id="4" creationId="{DB5C587F-44FC-49D7-AC56-C42BC92EC509}"/>
          </ac:graphicFrameMkLst>
        </pc:graphicFrameChg>
        <pc:graphicFrameChg chg="add mod">
          <ac:chgData name="Miriam Schreiber" userId="5a452ff8-f189-44a9-9767-da59f69398bf" providerId="ADAL" clId="{A7C712C2-6042-4F4E-869B-8BAF3B95E273}" dt="2022-05-01T17:35:30.562" v="55" actId="1076"/>
          <ac:graphicFrameMkLst>
            <pc:docMk/>
            <pc:sldMk cId="3186632296" sldId="264"/>
            <ac:graphicFrameMk id="5" creationId="{4C07B1E3-CABC-4822-9EAD-C7CEC73DC9E5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hutton-my.sharepoint.com/personal/miriam_schreiber_hutton_ac_uk/Documents/ERC_Meiosis/Bioinformatics/YunYuEMS/Results_April_202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hutton-my.sharepoint.com/personal/miriam_schreiber_hutton_ac_uk/Documents/ERC_Meiosis/Bioinformatics/YunYuEMS/Results_April_202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hutton-my.sharepoint.com/personal/miriam_schreiber_hutton_ac_uk/Documents/ERC_Meiosis/Bioinformatics/YunYuEMS/Results_April_202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hutton-my.sharepoint.com/personal/miriam_schreiber_hutton_ac_uk/Documents/ERC_Meiosis/Bioinformatics/YunYuEMS/Results_April_202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hutton-my.sharepoint.com/personal/miriam_schreiber_hutton_ac_uk/Documents/ERC_Meiosis/Bioinformatics/YunYuEMS/Results_April_202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hutton-my.sharepoint.com/personal/miriam_schreiber_hutton_ac_uk/Documents/ERC_Meiosis/Bioinformatics/YunYuEMS/Results_April_2022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https://hutton-my.sharepoint.com/personal/miriam_schreiber_hutton_ac_uk/Documents/ERC_Meiosis/Bioinformatics/YunYuEMS/Results_April_2022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Chr2H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9467283950617284E-2"/>
          <c:y val="5.6886458333333334E-2"/>
          <c:w val="0.90630601851851855"/>
          <c:h val="0.73093715277777782"/>
        </c:manualLayout>
      </c:layout>
      <c:lineChart>
        <c:grouping val="standard"/>
        <c:varyColors val="0"/>
        <c:ser>
          <c:idx val="0"/>
          <c:order val="0"/>
          <c:tx>
            <c:strRef>
              <c:f>Sheet1!$AG$3</c:f>
              <c:strCache>
                <c:ptCount val="1"/>
                <c:pt idx="0">
                  <c:v>BW230</c:v>
                </c:pt>
              </c:strCache>
            </c:strRef>
          </c:tx>
          <c:spPr>
            <a:ln w="28575" cap="rnd">
              <a:solidFill>
                <a:srgbClr val="D7191C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</c:strRef>
          </c:cat>
          <c:val>
            <c:numRef>
              <c:f>Sheet1!$AG$4:$AG$53</c:f>
              <c:numCache>
                <c:formatCode>General</c:formatCode>
                <c:ptCount val="50"/>
                <c:pt idx="0">
                  <c:v>9</c:v>
                </c:pt>
                <c:pt idx="1">
                  <c:v>2</c:v>
                </c:pt>
                <c:pt idx="2">
                  <c:v>6</c:v>
                </c:pt>
                <c:pt idx="3">
                  <c:v>0</c:v>
                </c:pt>
                <c:pt idx="4">
                  <c:v>4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1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1</c:v>
                </c:pt>
                <c:pt idx="42">
                  <c:v>4</c:v>
                </c:pt>
                <c:pt idx="43">
                  <c:v>1</c:v>
                </c:pt>
                <c:pt idx="44">
                  <c:v>2</c:v>
                </c:pt>
                <c:pt idx="45">
                  <c:v>2</c:v>
                </c:pt>
                <c:pt idx="46">
                  <c:v>1</c:v>
                </c:pt>
                <c:pt idx="47">
                  <c:v>9</c:v>
                </c:pt>
                <c:pt idx="48">
                  <c:v>1</c:v>
                </c:pt>
                <c:pt idx="49">
                  <c:v>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900-4981-B34F-E146E49BF91B}"/>
            </c:ext>
          </c:extLst>
        </c:ser>
        <c:ser>
          <c:idx val="1"/>
          <c:order val="1"/>
          <c:tx>
            <c:strRef>
              <c:f>Sheet1!$AH$3</c:f>
              <c:strCache>
                <c:ptCount val="1"/>
                <c:pt idx="0">
                  <c:v>Bowman</c:v>
                </c:pt>
              </c:strCache>
            </c:strRef>
          </c:tx>
          <c:spPr>
            <a:ln w="28575" cap="rnd">
              <a:solidFill>
                <a:srgbClr val="2C7BB6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</c:strRef>
          </c:cat>
          <c:val>
            <c:numRef>
              <c:f>Sheet1!$AH$4:$AH$53</c:f>
              <c:numCache>
                <c:formatCode>General</c:formatCode>
                <c:ptCount val="50"/>
                <c:pt idx="0">
                  <c:v>5</c:v>
                </c:pt>
                <c:pt idx="1">
                  <c:v>10</c:v>
                </c:pt>
                <c:pt idx="2">
                  <c:v>6</c:v>
                </c:pt>
                <c:pt idx="3">
                  <c:v>8</c:v>
                </c:pt>
                <c:pt idx="4">
                  <c:v>3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  <c:pt idx="8">
                  <c:v>1</c:v>
                </c:pt>
                <c:pt idx="9">
                  <c:v>2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1</c:v>
                </c:pt>
                <c:pt idx="38">
                  <c:v>0</c:v>
                </c:pt>
                <c:pt idx="39">
                  <c:v>3</c:v>
                </c:pt>
                <c:pt idx="40">
                  <c:v>0</c:v>
                </c:pt>
                <c:pt idx="41">
                  <c:v>4</c:v>
                </c:pt>
                <c:pt idx="42">
                  <c:v>5</c:v>
                </c:pt>
                <c:pt idx="43">
                  <c:v>4</c:v>
                </c:pt>
                <c:pt idx="44">
                  <c:v>4</c:v>
                </c:pt>
                <c:pt idx="45">
                  <c:v>6</c:v>
                </c:pt>
                <c:pt idx="46">
                  <c:v>5</c:v>
                </c:pt>
                <c:pt idx="47">
                  <c:v>10</c:v>
                </c:pt>
                <c:pt idx="48">
                  <c:v>4</c:v>
                </c:pt>
                <c:pt idx="49">
                  <c:v>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900-4981-B34F-E146E49BF9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23474751"/>
        <c:axId val="1523477247"/>
      </c:lineChart>
      <c:catAx>
        <c:axId val="1523474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% Physical map position along the chromsoome</a:t>
                </a:r>
              </a:p>
            </c:rich>
          </c:tx>
          <c:layout>
            <c:manualLayout>
              <c:xMode val="edge"/>
              <c:yMode val="edge"/>
              <c:x val="0.28169259259259261"/>
              <c:y val="0.912665277777777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7247"/>
        <c:crosses val="autoZero"/>
        <c:auto val="1"/>
        <c:lblAlgn val="ctr"/>
        <c:lblOffset val="100"/>
        <c:noMultiLvlLbl val="0"/>
      </c:catAx>
      <c:valAx>
        <c:axId val="152347724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of cross-overs per interval</a:t>
                </a:r>
              </a:p>
            </c:rich>
          </c:tx>
          <c:layout>
            <c:manualLayout>
              <c:xMode val="edge"/>
              <c:yMode val="edge"/>
              <c:x val="5.2811728395061718E-3"/>
              <c:y val="7.096631944444445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2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4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7018287037037039"/>
          <c:y val="2.9062847222222226E-2"/>
          <c:w val="0.30193781355333893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Chr1H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9467283950617284E-2"/>
          <c:y val="5.6886458333333334E-2"/>
          <c:w val="0.90630601851851855"/>
          <c:h val="0.73093715277777782"/>
        </c:manualLayout>
      </c:layout>
      <c:lineChart>
        <c:grouping val="standard"/>
        <c:varyColors val="0"/>
        <c:ser>
          <c:idx val="0"/>
          <c:order val="0"/>
          <c:tx>
            <c:strRef>
              <c:f>Sheet1!$AE$3</c:f>
              <c:strCache>
                <c:ptCount val="1"/>
                <c:pt idx="0">
                  <c:v>BW230</c:v>
                </c:pt>
              </c:strCache>
            </c:strRef>
          </c:tx>
          <c:spPr>
            <a:ln w="28575" cap="rnd">
              <a:solidFill>
                <a:srgbClr val="D7191C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</c:strRef>
          </c:cat>
          <c:val>
            <c:numRef>
              <c:f>Sheet1!$AE$4:$AE$53</c:f>
              <c:numCache>
                <c:formatCode>General</c:formatCode>
                <c:ptCount val="50"/>
                <c:pt idx="0">
                  <c:v>5</c:v>
                </c:pt>
                <c:pt idx="1">
                  <c:v>6</c:v>
                </c:pt>
                <c:pt idx="2">
                  <c:v>2</c:v>
                </c:pt>
                <c:pt idx="3">
                  <c:v>1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1</c:v>
                </c:pt>
                <c:pt idx="39">
                  <c:v>0</c:v>
                </c:pt>
                <c:pt idx="40">
                  <c:v>1</c:v>
                </c:pt>
                <c:pt idx="41">
                  <c:v>1</c:v>
                </c:pt>
                <c:pt idx="42">
                  <c:v>0</c:v>
                </c:pt>
                <c:pt idx="43">
                  <c:v>2</c:v>
                </c:pt>
                <c:pt idx="44">
                  <c:v>0</c:v>
                </c:pt>
                <c:pt idx="45">
                  <c:v>2</c:v>
                </c:pt>
                <c:pt idx="46">
                  <c:v>1</c:v>
                </c:pt>
                <c:pt idx="47">
                  <c:v>4</c:v>
                </c:pt>
                <c:pt idx="48">
                  <c:v>5</c:v>
                </c:pt>
                <c:pt idx="49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800-4B9C-AA50-1D6AD7102CDC}"/>
            </c:ext>
          </c:extLst>
        </c:ser>
        <c:ser>
          <c:idx val="1"/>
          <c:order val="1"/>
          <c:tx>
            <c:strRef>
              <c:f>Sheet1!$AF$3</c:f>
              <c:strCache>
                <c:ptCount val="1"/>
                <c:pt idx="0">
                  <c:v>Bowman</c:v>
                </c:pt>
              </c:strCache>
            </c:strRef>
          </c:tx>
          <c:spPr>
            <a:ln w="28575" cap="rnd">
              <a:solidFill>
                <a:srgbClr val="2C7BB6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</c:strRef>
          </c:cat>
          <c:val>
            <c:numRef>
              <c:f>Sheet1!$AF$4:$AF$53</c:f>
              <c:numCache>
                <c:formatCode>General</c:formatCode>
                <c:ptCount val="50"/>
                <c:pt idx="0">
                  <c:v>3</c:v>
                </c:pt>
                <c:pt idx="1">
                  <c:v>6</c:v>
                </c:pt>
                <c:pt idx="2">
                  <c:v>6</c:v>
                </c:pt>
                <c:pt idx="3">
                  <c:v>5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1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1</c:v>
                </c:pt>
                <c:pt idx="40">
                  <c:v>0</c:v>
                </c:pt>
                <c:pt idx="41">
                  <c:v>1</c:v>
                </c:pt>
                <c:pt idx="42">
                  <c:v>3</c:v>
                </c:pt>
                <c:pt idx="43">
                  <c:v>3</c:v>
                </c:pt>
                <c:pt idx="44">
                  <c:v>3</c:v>
                </c:pt>
                <c:pt idx="45">
                  <c:v>7</c:v>
                </c:pt>
                <c:pt idx="46">
                  <c:v>6</c:v>
                </c:pt>
                <c:pt idx="47">
                  <c:v>7</c:v>
                </c:pt>
                <c:pt idx="48">
                  <c:v>12</c:v>
                </c:pt>
                <c:pt idx="49">
                  <c:v>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800-4B9C-AA50-1D6AD7102C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23474751"/>
        <c:axId val="1523477247"/>
      </c:lineChart>
      <c:catAx>
        <c:axId val="1523474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% Physical map position along the chromsoome</a:t>
                </a:r>
              </a:p>
            </c:rich>
          </c:tx>
          <c:layout>
            <c:manualLayout>
              <c:xMode val="edge"/>
              <c:yMode val="edge"/>
              <c:x val="0.28169259259259261"/>
              <c:y val="0.912665277777777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7247"/>
        <c:crosses val="autoZero"/>
        <c:auto val="1"/>
        <c:lblAlgn val="ctr"/>
        <c:lblOffset val="100"/>
        <c:noMultiLvlLbl val="0"/>
      </c:catAx>
      <c:valAx>
        <c:axId val="152347724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of cross-overs per interval</a:t>
                </a:r>
              </a:p>
            </c:rich>
          </c:tx>
          <c:layout>
            <c:manualLayout>
              <c:xMode val="edge"/>
              <c:yMode val="edge"/>
              <c:x val="5.2811728395061718E-3"/>
              <c:y val="7.096631944444445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2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4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7018287037037039"/>
          <c:y val="2.9062847222222226E-2"/>
          <c:w val="0.30193781355333893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Chr4H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9467283950617284E-2"/>
          <c:y val="5.6886458333333334E-2"/>
          <c:w val="0.90630601851851855"/>
          <c:h val="0.73093715277777782"/>
        </c:manualLayout>
      </c:layout>
      <c:lineChart>
        <c:grouping val="standard"/>
        <c:varyColors val="0"/>
        <c:ser>
          <c:idx val="0"/>
          <c:order val="0"/>
          <c:tx>
            <c:strRef>
              <c:f>Sheet1!$AK$3</c:f>
              <c:strCache>
                <c:ptCount val="1"/>
                <c:pt idx="0">
                  <c:v>BW230</c:v>
                </c:pt>
              </c:strCache>
            </c:strRef>
          </c:tx>
          <c:spPr>
            <a:ln w="28575" cap="rnd">
              <a:solidFill>
                <a:srgbClr val="D7191C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</c:strRef>
          </c:cat>
          <c:val>
            <c:numRef>
              <c:f>Sheet1!$AK$4:$AK$53</c:f>
              <c:numCache>
                <c:formatCode>General</c:formatCode>
                <c:ptCount val="50"/>
                <c:pt idx="0">
                  <c:v>4</c:v>
                </c:pt>
                <c:pt idx="1">
                  <c:v>5</c:v>
                </c:pt>
                <c:pt idx="2">
                  <c:v>4</c:v>
                </c:pt>
                <c:pt idx="3">
                  <c:v>0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1</c:v>
                </c:pt>
                <c:pt idx="40">
                  <c:v>0</c:v>
                </c:pt>
                <c:pt idx="41">
                  <c:v>1</c:v>
                </c:pt>
                <c:pt idx="42">
                  <c:v>0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4</c:v>
                </c:pt>
                <c:pt idx="47">
                  <c:v>1</c:v>
                </c:pt>
                <c:pt idx="48">
                  <c:v>3</c:v>
                </c:pt>
                <c:pt idx="49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AC8-4BAC-BC78-530E0A90272C}"/>
            </c:ext>
          </c:extLst>
        </c:ser>
        <c:ser>
          <c:idx val="1"/>
          <c:order val="1"/>
          <c:tx>
            <c:strRef>
              <c:f>Sheet1!$AL$3</c:f>
              <c:strCache>
                <c:ptCount val="1"/>
                <c:pt idx="0">
                  <c:v>Bowman</c:v>
                </c:pt>
              </c:strCache>
            </c:strRef>
          </c:tx>
          <c:spPr>
            <a:ln w="28575" cap="rnd">
              <a:solidFill>
                <a:srgbClr val="2C7BB6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</c:strRef>
          </c:cat>
          <c:val>
            <c:numRef>
              <c:f>Sheet1!$AL$4:$AL$53</c:f>
              <c:numCache>
                <c:formatCode>General</c:formatCode>
                <c:ptCount val="50"/>
                <c:pt idx="0">
                  <c:v>5</c:v>
                </c:pt>
                <c:pt idx="1">
                  <c:v>4</c:v>
                </c:pt>
                <c:pt idx="2">
                  <c:v>9</c:v>
                </c:pt>
                <c:pt idx="3">
                  <c:v>3</c:v>
                </c:pt>
                <c:pt idx="4">
                  <c:v>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1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4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1</c:v>
                </c:pt>
                <c:pt idx="46">
                  <c:v>2</c:v>
                </c:pt>
                <c:pt idx="47">
                  <c:v>5</c:v>
                </c:pt>
                <c:pt idx="48">
                  <c:v>3</c:v>
                </c:pt>
                <c:pt idx="49">
                  <c:v>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AC8-4BAC-BC78-530E0A9027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23474751"/>
        <c:axId val="1523477247"/>
      </c:lineChart>
      <c:catAx>
        <c:axId val="1523474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% Physical map position along the chromsoome</a:t>
                </a:r>
              </a:p>
            </c:rich>
          </c:tx>
          <c:layout>
            <c:manualLayout>
              <c:xMode val="edge"/>
              <c:yMode val="edge"/>
              <c:x val="0.28169259259259261"/>
              <c:y val="0.912665277777777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7247"/>
        <c:crosses val="autoZero"/>
        <c:auto val="1"/>
        <c:lblAlgn val="ctr"/>
        <c:lblOffset val="100"/>
        <c:noMultiLvlLbl val="0"/>
      </c:catAx>
      <c:valAx>
        <c:axId val="152347724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of cross-overs per interval</a:t>
                </a:r>
              </a:p>
            </c:rich>
          </c:tx>
          <c:layout>
            <c:manualLayout>
              <c:xMode val="edge"/>
              <c:yMode val="edge"/>
              <c:x val="5.2811728395061718E-3"/>
              <c:y val="7.096631944444445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2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4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7018287037037039"/>
          <c:y val="2.9062847222222226E-2"/>
          <c:w val="0.30193781355333893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Chr3H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9467283950617284E-2"/>
          <c:y val="5.6886458333333334E-2"/>
          <c:w val="0.90630601851851855"/>
          <c:h val="0.73093715277777782"/>
        </c:manualLayout>
      </c:layout>
      <c:lineChart>
        <c:grouping val="standard"/>
        <c:varyColors val="0"/>
        <c:ser>
          <c:idx val="0"/>
          <c:order val="0"/>
          <c:tx>
            <c:strRef>
              <c:f>Sheet1!$AI$3</c:f>
              <c:strCache>
                <c:ptCount val="1"/>
                <c:pt idx="0">
                  <c:v>BW230</c:v>
                </c:pt>
              </c:strCache>
            </c:strRef>
          </c:tx>
          <c:spPr>
            <a:ln w="28575" cap="rnd">
              <a:solidFill>
                <a:srgbClr val="D7191C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</c:strRef>
          </c:cat>
          <c:val>
            <c:numRef>
              <c:f>Sheet1!$AI$4:$AI$53</c:f>
              <c:numCache>
                <c:formatCode>General</c:formatCode>
                <c:ptCount val="50"/>
                <c:pt idx="0">
                  <c:v>7</c:v>
                </c:pt>
                <c:pt idx="1">
                  <c:v>6</c:v>
                </c:pt>
                <c:pt idx="2">
                  <c:v>0</c:v>
                </c:pt>
                <c:pt idx="3">
                  <c:v>5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1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1</c:v>
                </c:pt>
                <c:pt idx="37">
                  <c:v>0</c:v>
                </c:pt>
                <c:pt idx="38">
                  <c:v>0</c:v>
                </c:pt>
                <c:pt idx="39">
                  <c:v>1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3</c:v>
                </c:pt>
                <c:pt idx="45">
                  <c:v>3</c:v>
                </c:pt>
                <c:pt idx="46">
                  <c:v>0</c:v>
                </c:pt>
                <c:pt idx="47">
                  <c:v>4</c:v>
                </c:pt>
                <c:pt idx="48">
                  <c:v>3</c:v>
                </c:pt>
                <c:pt idx="49">
                  <c:v>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857-4BDC-84C7-009899F1639D}"/>
            </c:ext>
          </c:extLst>
        </c:ser>
        <c:ser>
          <c:idx val="1"/>
          <c:order val="1"/>
          <c:tx>
            <c:strRef>
              <c:f>Sheet1!$AJ$3</c:f>
              <c:strCache>
                <c:ptCount val="1"/>
                <c:pt idx="0">
                  <c:v>Bowman</c:v>
                </c:pt>
              </c:strCache>
            </c:strRef>
          </c:tx>
          <c:spPr>
            <a:ln w="28575" cap="rnd">
              <a:solidFill>
                <a:srgbClr val="2C7BB6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</c:strRef>
          </c:cat>
          <c:val>
            <c:numRef>
              <c:f>Sheet1!$AJ$4:$AJ$53</c:f>
              <c:numCache>
                <c:formatCode>General</c:formatCode>
                <c:ptCount val="50"/>
                <c:pt idx="0">
                  <c:v>4</c:v>
                </c:pt>
                <c:pt idx="1">
                  <c:v>4</c:v>
                </c:pt>
                <c:pt idx="2">
                  <c:v>9</c:v>
                </c:pt>
                <c:pt idx="3">
                  <c:v>4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1</c:v>
                </c:pt>
                <c:pt idx="36">
                  <c:v>1</c:v>
                </c:pt>
                <c:pt idx="37">
                  <c:v>3</c:v>
                </c:pt>
                <c:pt idx="38">
                  <c:v>0</c:v>
                </c:pt>
                <c:pt idx="39">
                  <c:v>1</c:v>
                </c:pt>
                <c:pt idx="40">
                  <c:v>0</c:v>
                </c:pt>
                <c:pt idx="41">
                  <c:v>3</c:v>
                </c:pt>
                <c:pt idx="42">
                  <c:v>1</c:v>
                </c:pt>
                <c:pt idx="43">
                  <c:v>6</c:v>
                </c:pt>
                <c:pt idx="44">
                  <c:v>3</c:v>
                </c:pt>
                <c:pt idx="45">
                  <c:v>4</c:v>
                </c:pt>
                <c:pt idx="46">
                  <c:v>4</c:v>
                </c:pt>
                <c:pt idx="47">
                  <c:v>5</c:v>
                </c:pt>
                <c:pt idx="48">
                  <c:v>6</c:v>
                </c:pt>
                <c:pt idx="49">
                  <c:v>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857-4BDC-84C7-009899F163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23474751"/>
        <c:axId val="1523477247"/>
      </c:lineChart>
      <c:catAx>
        <c:axId val="1523474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% Physical map position along the chromsoome</a:t>
                </a:r>
              </a:p>
            </c:rich>
          </c:tx>
          <c:layout>
            <c:manualLayout>
              <c:xMode val="edge"/>
              <c:yMode val="edge"/>
              <c:x val="0.28169259259259261"/>
              <c:y val="0.912665277777777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7247"/>
        <c:crosses val="autoZero"/>
        <c:auto val="1"/>
        <c:lblAlgn val="ctr"/>
        <c:lblOffset val="100"/>
        <c:noMultiLvlLbl val="0"/>
      </c:catAx>
      <c:valAx>
        <c:axId val="152347724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of cross-overs per interval</a:t>
                </a:r>
              </a:p>
            </c:rich>
          </c:tx>
          <c:layout>
            <c:manualLayout>
              <c:xMode val="edge"/>
              <c:yMode val="edge"/>
              <c:x val="5.2811728395061718E-3"/>
              <c:y val="7.096631944444445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2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4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7018287037037039"/>
          <c:y val="2.9062847222222226E-2"/>
          <c:w val="0.30193781355333893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Chr5H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9467283950617284E-2"/>
          <c:y val="5.6886458333333334E-2"/>
          <c:w val="0.90630601851851855"/>
          <c:h val="0.73093715277777782"/>
        </c:manualLayout>
      </c:layout>
      <c:lineChart>
        <c:grouping val="standard"/>
        <c:varyColors val="0"/>
        <c:ser>
          <c:idx val="0"/>
          <c:order val="0"/>
          <c:tx>
            <c:strRef>
              <c:f>Sheet1!$AM$3</c:f>
              <c:strCache>
                <c:ptCount val="1"/>
                <c:pt idx="0">
                  <c:v>BW230</c:v>
                </c:pt>
              </c:strCache>
            </c:strRef>
          </c:tx>
          <c:spPr>
            <a:ln w="28575" cap="rnd">
              <a:solidFill>
                <a:srgbClr val="D7191C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</c:strRef>
          </c:cat>
          <c:val>
            <c:numRef>
              <c:f>Sheet1!$AM$4:$AM$53</c:f>
              <c:numCache>
                <c:formatCode>General</c:formatCode>
                <c:ptCount val="50"/>
                <c:pt idx="0">
                  <c:v>8</c:v>
                </c:pt>
                <c:pt idx="1">
                  <c:v>4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1</c:v>
                </c:pt>
                <c:pt idx="32">
                  <c:v>0</c:v>
                </c:pt>
                <c:pt idx="33">
                  <c:v>1</c:v>
                </c:pt>
                <c:pt idx="34">
                  <c:v>1</c:v>
                </c:pt>
                <c:pt idx="35">
                  <c:v>0</c:v>
                </c:pt>
                <c:pt idx="36">
                  <c:v>1</c:v>
                </c:pt>
                <c:pt idx="37">
                  <c:v>2</c:v>
                </c:pt>
                <c:pt idx="38">
                  <c:v>0</c:v>
                </c:pt>
                <c:pt idx="39">
                  <c:v>1</c:v>
                </c:pt>
                <c:pt idx="40">
                  <c:v>3</c:v>
                </c:pt>
                <c:pt idx="41">
                  <c:v>1</c:v>
                </c:pt>
                <c:pt idx="42">
                  <c:v>4</c:v>
                </c:pt>
                <c:pt idx="43">
                  <c:v>0</c:v>
                </c:pt>
                <c:pt idx="44">
                  <c:v>0</c:v>
                </c:pt>
                <c:pt idx="45">
                  <c:v>7</c:v>
                </c:pt>
                <c:pt idx="46">
                  <c:v>2</c:v>
                </c:pt>
                <c:pt idx="47">
                  <c:v>1</c:v>
                </c:pt>
                <c:pt idx="48">
                  <c:v>1</c:v>
                </c:pt>
                <c:pt idx="49">
                  <c:v>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FFA-48B9-9C26-6814562EDC59}"/>
            </c:ext>
          </c:extLst>
        </c:ser>
        <c:ser>
          <c:idx val="1"/>
          <c:order val="1"/>
          <c:tx>
            <c:strRef>
              <c:f>Sheet1!$AN$3</c:f>
              <c:strCache>
                <c:ptCount val="1"/>
                <c:pt idx="0">
                  <c:v>Bowman</c:v>
                </c:pt>
              </c:strCache>
            </c:strRef>
          </c:tx>
          <c:spPr>
            <a:ln w="28575" cap="rnd">
              <a:solidFill>
                <a:srgbClr val="2C7BB6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</c:strRef>
          </c:cat>
          <c:val>
            <c:numRef>
              <c:f>Sheet1!$AN$4:$AN$53</c:f>
              <c:numCache>
                <c:formatCode>General</c:formatCode>
                <c:ptCount val="50"/>
                <c:pt idx="0">
                  <c:v>12</c:v>
                </c:pt>
                <c:pt idx="1">
                  <c:v>10</c:v>
                </c:pt>
                <c:pt idx="2">
                  <c:v>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2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1</c:v>
                </c:pt>
                <c:pt idx="34">
                  <c:v>3</c:v>
                </c:pt>
                <c:pt idx="35">
                  <c:v>0</c:v>
                </c:pt>
                <c:pt idx="36">
                  <c:v>0</c:v>
                </c:pt>
                <c:pt idx="37">
                  <c:v>1</c:v>
                </c:pt>
                <c:pt idx="38">
                  <c:v>3</c:v>
                </c:pt>
                <c:pt idx="39">
                  <c:v>1</c:v>
                </c:pt>
                <c:pt idx="40">
                  <c:v>1</c:v>
                </c:pt>
                <c:pt idx="41">
                  <c:v>7</c:v>
                </c:pt>
                <c:pt idx="42">
                  <c:v>7</c:v>
                </c:pt>
                <c:pt idx="43">
                  <c:v>7</c:v>
                </c:pt>
                <c:pt idx="44">
                  <c:v>10</c:v>
                </c:pt>
                <c:pt idx="45">
                  <c:v>4</c:v>
                </c:pt>
                <c:pt idx="46">
                  <c:v>6</c:v>
                </c:pt>
                <c:pt idx="47">
                  <c:v>4</c:v>
                </c:pt>
                <c:pt idx="48">
                  <c:v>5</c:v>
                </c:pt>
                <c:pt idx="4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FFA-48B9-9C26-6814562EDC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23474751"/>
        <c:axId val="1523477247"/>
      </c:lineChart>
      <c:catAx>
        <c:axId val="1523474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% Physical map position along the chromsoome</a:t>
                </a:r>
              </a:p>
            </c:rich>
          </c:tx>
          <c:layout>
            <c:manualLayout>
              <c:xMode val="edge"/>
              <c:yMode val="edge"/>
              <c:x val="0.28169259259259261"/>
              <c:y val="0.912665277777777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7247"/>
        <c:crosses val="autoZero"/>
        <c:auto val="1"/>
        <c:lblAlgn val="ctr"/>
        <c:lblOffset val="100"/>
        <c:noMultiLvlLbl val="0"/>
      </c:catAx>
      <c:valAx>
        <c:axId val="152347724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of cross-overs per interval</a:t>
                </a:r>
              </a:p>
            </c:rich>
          </c:tx>
          <c:layout>
            <c:manualLayout>
              <c:xMode val="edge"/>
              <c:yMode val="edge"/>
              <c:x val="5.2811728395061718E-3"/>
              <c:y val="7.096631944444445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2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4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7018287037037039"/>
          <c:y val="2.9062847222222226E-2"/>
          <c:w val="0.30193781355333893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Chr6H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9467283950617284E-2"/>
          <c:y val="5.6886458333333334E-2"/>
          <c:w val="0.90630601851851855"/>
          <c:h val="0.73093715277777782"/>
        </c:manualLayout>
      </c:layout>
      <c:lineChart>
        <c:grouping val="standard"/>
        <c:varyColors val="0"/>
        <c:ser>
          <c:idx val="0"/>
          <c:order val="0"/>
          <c:tx>
            <c:strRef>
              <c:f>Sheet1!$AO$3</c:f>
              <c:strCache>
                <c:ptCount val="1"/>
                <c:pt idx="0">
                  <c:v>BW230</c:v>
                </c:pt>
              </c:strCache>
            </c:strRef>
          </c:tx>
          <c:spPr>
            <a:ln w="28575" cap="rnd">
              <a:solidFill>
                <a:srgbClr val="D7191C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</c:strRef>
          </c:cat>
          <c:val>
            <c:numRef>
              <c:f>Sheet1!$AO$4:$AO$53</c:f>
              <c:numCache>
                <c:formatCode>General</c:formatCode>
                <c:ptCount val="50"/>
                <c:pt idx="0">
                  <c:v>5</c:v>
                </c:pt>
                <c:pt idx="1">
                  <c:v>7</c:v>
                </c:pt>
                <c:pt idx="2">
                  <c:v>4</c:v>
                </c:pt>
                <c:pt idx="3">
                  <c:v>5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1</c:v>
                </c:pt>
                <c:pt idx="32">
                  <c:v>0</c:v>
                </c:pt>
                <c:pt idx="33">
                  <c:v>0</c:v>
                </c:pt>
                <c:pt idx="34">
                  <c:v>1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1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1</c:v>
                </c:pt>
                <c:pt idx="45">
                  <c:v>2</c:v>
                </c:pt>
                <c:pt idx="46">
                  <c:v>1</c:v>
                </c:pt>
                <c:pt idx="47">
                  <c:v>3</c:v>
                </c:pt>
                <c:pt idx="48">
                  <c:v>2</c:v>
                </c:pt>
                <c:pt idx="49">
                  <c:v>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F03-4F0D-8D77-B475A771AD90}"/>
            </c:ext>
          </c:extLst>
        </c:ser>
        <c:ser>
          <c:idx val="1"/>
          <c:order val="1"/>
          <c:tx>
            <c:strRef>
              <c:f>Sheet1!$AP$3</c:f>
              <c:strCache>
                <c:ptCount val="1"/>
                <c:pt idx="0">
                  <c:v>Bowman</c:v>
                </c:pt>
              </c:strCache>
            </c:strRef>
          </c:tx>
          <c:spPr>
            <a:ln w="28575" cap="rnd">
              <a:solidFill>
                <a:srgbClr val="2C7BB6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</c:strRef>
          </c:cat>
          <c:val>
            <c:numRef>
              <c:f>Sheet1!$AP$4:$AP$53</c:f>
              <c:numCache>
                <c:formatCode>General</c:formatCode>
                <c:ptCount val="50"/>
                <c:pt idx="0">
                  <c:v>2</c:v>
                </c:pt>
                <c:pt idx="1">
                  <c:v>7</c:v>
                </c:pt>
                <c:pt idx="2">
                  <c:v>6</c:v>
                </c:pt>
                <c:pt idx="3">
                  <c:v>6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3</c:v>
                </c:pt>
                <c:pt idx="11">
                  <c:v>1</c:v>
                </c:pt>
                <c:pt idx="12">
                  <c:v>0</c:v>
                </c:pt>
                <c:pt idx="13">
                  <c:v>0</c:v>
                </c:pt>
                <c:pt idx="14">
                  <c:v>1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2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2</c:v>
                </c:pt>
                <c:pt idx="41">
                  <c:v>3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3</c:v>
                </c:pt>
                <c:pt idx="46">
                  <c:v>1</c:v>
                </c:pt>
                <c:pt idx="47">
                  <c:v>6</c:v>
                </c:pt>
                <c:pt idx="48">
                  <c:v>6</c:v>
                </c:pt>
                <c:pt idx="49">
                  <c:v>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F03-4F0D-8D77-B475A771AD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23474751"/>
        <c:axId val="1523477247"/>
      </c:lineChart>
      <c:catAx>
        <c:axId val="1523474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% Physical map position along the chromsoome</a:t>
                </a:r>
              </a:p>
            </c:rich>
          </c:tx>
          <c:layout>
            <c:manualLayout>
              <c:xMode val="edge"/>
              <c:yMode val="edge"/>
              <c:x val="0.28169259259259261"/>
              <c:y val="0.912665277777777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7247"/>
        <c:crosses val="autoZero"/>
        <c:auto val="1"/>
        <c:lblAlgn val="ctr"/>
        <c:lblOffset val="100"/>
        <c:noMultiLvlLbl val="0"/>
      </c:catAx>
      <c:valAx>
        <c:axId val="152347724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of cross-overs per interval</a:t>
                </a:r>
              </a:p>
            </c:rich>
          </c:tx>
          <c:layout>
            <c:manualLayout>
              <c:xMode val="edge"/>
              <c:yMode val="edge"/>
              <c:x val="5.2811728395061718E-3"/>
              <c:y val="7.096631944444445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2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4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7018287037037039"/>
          <c:y val="2.9062847222222226E-2"/>
          <c:w val="0.30193781355333893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Chr7H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9467283950617284E-2"/>
          <c:y val="5.6886458333333334E-2"/>
          <c:w val="0.90630601851851855"/>
          <c:h val="0.73093715277777782"/>
        </c:manualLayout>
      </c:layout>
      <c:lineChart>
        <c:grouping val="standard"/>
        <c:varyColors val="0"/>
        <c:ser>
          <c:idx val="0"/>
          <c:order val="0"/>
          <c:tx>
            <c:strRef>
              <c:f>Sheet1!$AQ$3</c:f>
              <c:strCache>
                <c:ptCount val="1"/>
                <c:pt idx="0">
                  <c:v>BW230</c:v>
                </c:pt>
              </c:strCache>
            </c:strRef>
          </c:tx>
          <c:spPr>
            <a:ln w="28575" cap="rnd">
              <a:solidFill>
                <a:srgbClr val="D7191C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  <c:extLst/>
            </c:strRef>
          </c:cat>
          <c:val>
            <c:numRef>
              <c:f>Sheet1!$AQ$4:$AQ$53</c:f>
              <c:numCache>
                <c:formatCode>General</c:formatCode>
                <c:ptCount val="50"/>
                <c:pt idx="0">
                  <c:v>5</c:v>
                </c:pt>
                <c:pt idx="1">
                  <c:v>4</c:v>
                </c:pt>
                <c:pt idx="2">
                  <c:v>2</c:v>
                </c:pt>
                <c:pt idx="3">
                  <c:v>1</c:v>
                </c:pt>
                <c:pt idx="4">
                  <c:v>3</c:v>
                </c:pt>
                <c:pt idx="5">
                  <c:v>0</c:v>
                </c:pt>
                <c:pt idx="6">
                  <c:v>2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1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2</c:v>
                </c:pt>
                <c:pt idx="45">
                  <c:v>2</c:v>
                </c:pt>
                <c:pt idx="46">
                  <c:v>6</c:v>
                </c:pt>
                <c:pt idx="47">
                  <c:v>1</c:v>
                </c:pt>
                <c:pt idx="48">
                  <c:v>5</c:v>
                </c:pt>
                <c:pt idx="49">
                  <c:v>5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0-5C6E-4277-A7B3-2096859E6535}"/>
            </c:ext>
          </c:extLst>
        </c:ser>
        <c:ser>
          <c:idx val="1"/>
          <c:order val="1"/>
          <c:tx>
            <c:strRef>
              <c:f>Sheet1!$AR$3</c:f>
              <c:strCache>
                <c:ptCount val="1"/>
                <c:pt idx="0">
                  <c:v>Bowman</c:v>
                </c:pt>
              </c:strCache>
            </c:strRef>
          </c:tx>
          <c:spPr>
            <a:ln w="28575" cap="rnd">
              <a:solidFill>
                <a:srgbClr val="2C7BB6"/>
              </a:solidFill>
              <a:round/>
            </a:ln>
            <a:effectLst/>
          </c:spPr>
          <c:marker>
            <c:symbol val="none"/>
          </c:marker>
          <c:cat>
            <c:strRef>
              <c:f>Sheet1!$AD$4:$AD$53</c:f>
              <c:strCache>
                <c:ptCount val="50"/>
                <c:pt idx="0">
                  <c:v>1-2</c:v>
                </c:pt>
                <c:pt idx="1">
                  <c:v>3-4</c:v>
                </c:pt>
                <c:pt idx="2">
                  <c:v>5-6</c:v>
                </c:pt>
                <c:pt idx="3">
                  <c:v>7-8</c:v>
                </c:pt>
                <c:pt idx="4">
                  <c:v>9-10</c:v>
                </c:pt>
                <c:pt idx="5">
                  <c:v>11-12</c:v>
                </c:pt>
                <c:pt idx="6">
                  <c:v>13-14</c:v>
                </c:pt>
                <c:pt idx="7">
                  <c:v>15-16</c:v>
                </c:pt>
                <c:pt idx="8">
                  <c:v>17-18</c:v>
                </c:pt>
                <c:pt idx="9">
                  <c:v>19-20</c:v>
                </c:pt>
                <c:pt idx="10">
                  <c:v>21-22</c:v>
                </c:pt>
                <c:pt idx="11">
                  <c:v>23-24</c:v>
                </c:pt>
                <c:pt idx="12">
                  <c:v>25-26</c:v>
                </c:pt>
                <c:pt idx="13">
                  <c:v>27-28</c:v>
                </c:pt>
                <c:pt idx="14">
                  <c:v>29-30</c:v>
                </c:pt>
                <c:pt idx="15">
                  <c:v>31-32</c:v>
                </c:pt>
                <c:pt idx="16">
                  <c:v>33-34</c:v>
                </c:pt>
                <c:pt idx="17">
                  <c:v>35-36</c:v>
                </c:pt>
                <c:pt idx="18">
                  <c:v>37-38</c:v>
                </c:pt>
                <c:pt idx="19">
                  <c:v>39-40</c:v>
                </c:pt>
                <c:pt idx="20">
                  <c:v>41-42</c:v>
                </c:pt>
                <c:pt idx="21">
                  <c:v>43-44</c:v>
                </c:pt>
                <c:pt idx="22">
                  <c:v>45-46</c:v>
                </c:pt>
                <c:pt idx="23">
                  <c:v>47-48</c:v>
                </c:pt>
                <c:pt idx="24">
                  <c:v>49-50</c:v>
                </c:pt>
                <c:pt idx="25">
                  <c:v>51-52</c:v>
                </c:pt>
                <c:pt idx="26">
                  <c:v>53-54</c:v>
                </c:pt>
                <c:pt idx="27">
                  <c:v>55-56</c:v>
                </c:pt>
                <c:pt idx="28">
                  <c:v>57-58</c:v>
                </c:pt>
                <c:pt idx="29">
                  <c:v>59-60</c:v>
                </c:pt>
                <c:pt idx="30">
                  <c:v>61-62</c:v>
                </c:pt>
                <c:pt idx="31">
                  <c:v>63-64</c:v>
                </c:pt>
                <c:pt idx="32">
                  <c:v>65-66</c:v>
                </c:pt>
                <c:pt idx="33">
                  <c:v>67-68</c:v>
                </c:pt>
                <c:pt idx="34">
                  <c:v>69-70</c:v>
                </c:pt>
                <c:pt idx="35">
                  <c:v>71-72</c:v>
                </c:pt>
                <c:pt idx="36">
                  <c:v>73-74</c:v>
                </c:pt>
                <c:pt idx="37">
                  <c:v>75-76</c:v>
                </c:pt>
                <c:pt idx="38">
                  <c:v>77-78</c:v>
                </c:pt>
                <c:pt idx="39">
                  <c:v>79-80</c:v>
                </c:pt>
                <c:pt idx="40">
                  <c:v>81-82</c:v>
                </c:pt>
                <c:pt idx="41">
                  <c:v>83-84</c:v>
                </c:pt>
                <c:pt idx="42">
                  <c:v>85-86</c:v>
                </c:pt>
                <c:pt idx="43">
                  <c:v>87-88</c:v>
                </c:pt>
                <c:pt idx="44">
                  <c:v>89-90</c:v>
                </c:pt>
                <c:pt idx="45">
                  <c:v>91-92</c:v>
                </c:pt>
                <c:pt idx="46">
                  <c:v>93-94</c:v>
                </c:pt>
                <c:pt idx="47">
                  <c:v>95-96</c:v>
                </c:pt>
                <c:pt idx="48">
                  <c:v>97-98</c:v>
                </c:pt>
                <c:pt idx="49">
                  <c:v>99-100</c:v>
                </c:pt>
              </c:strCache>
              <c:extLst/>
            </c:strRef>
          </c:cat>
          <c:val>
            <c:numRef>
              <c:f>Sheet1!$AR$4:$AR$53</c:f>
              <c:numCache>
                <c:formatCode>General</c:formatCode>
                <c:ptCount val="50"/>
                <c:pt idx="0">
                  <c:v>7</c:v>
                </c:pt>
                <c:pt idx="1">
                  <c:v>14</c:v>
                </c:pt>
                <c:pt idx="2">
                  <c:v>3</c:v>
                </c:pt>
                <c:pt idx="3">
                  <c:v>8</c:v>
                </c:pt>
                <c:pt idx="4">
                  <c:v>7</c:v>
                </c:pt>
                <c:pt idx="5">
                  <c:v>8</c:v>
                </c:pt>
                <c:pt idx="6">
                  <c:v>3</c:v>
                </c:pt>
                <c:pt idx="7">
                  <c:v>2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2</c:v>
                </c:pt>
                <c:pt idx="38">
                  <c:v>0</c:v>
                </c:pt>
                <c:pt idx="39">
                  <c:v>0</c:v>
                </c:pt>
                <c:pt idx="40">
                  <c:v>1</c:v>
                </c:pt>
                <c:pt idx="41">
                  <c:v>1</c:v>
                </c:pt>
                <c:pt idx="42">
                  <c:v>0</c:v>
                </c:pt>
                <c:pt idx="43">
                  <c:v>0</c:v>
                </c:pt>
                <c:pt idx="44">
                  <c:v>2</c:v>
                </c:pt>
                <c:pt idx="45">
                  <c:v>2</c:v>
                </c:pt>
                <c:pt idx="46">
                  <c:v>12</c:v>
                </c:pt>
                <c:pt idx="47">
                  <c:v>3</c:v>
                </c:pt>
                <c:pt idx="48">
                  <c:v>7</c:v>
                </c:pt>
                <c:pt idx="49">
                  <c:v>3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1-5C6E-4277-A7B3-2096859E65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23474751"/>
        <c:axId val="1523477247"/>
      </c:lineChart>
      <c:catAx>
        <c:axId val="1523474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% Physical map position along the chromsoome</a:t>
                </a:r>
              </a:p>
            </c:rich>
          </c:tx>
          <c:layout>
            <c:manualLayout>
              <c:xMode val="edge"/>
              <c:yMode val="edge"/>
              <c:x val="0.28169259259259261"/>
              <c:y val="0.912665277777777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7247"/>
        <c:crosses val="autoZero"/>
        <c:auto val="1"/>
        <c:lblAlgn val="ctr"/>
        <c:lblOffset val="100"/>
        <c:noMultiLvlLbl val="0"/>
      </c:catAx>
      <c:valAx>
        <c:axId val="152347724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of cross-overs per interval</a:t>
                </a:r>
              </a:p>
            </c:rich>
          </c:tx>
          <c:layout>
            <c:manualLayout>
              <c:xMode val="edge"/>
              <c:yMode val="edge"/>
              <c:x val="5.2811728395061718E-3"/>
              <c:y val="7.096631944444445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2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3474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7018287037037039"/>
          <c:y val="2.9062847222222226E-2"/>
          <c:w val="0.30193781355333893"/>
          <c:h val="7.38404053659959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D2ED9E-5FC9-4500-BE20-C9FD8C4348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CF84AB7-37AB-433C-B092-D8796D1E08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11772C-C832-46F4-9292-77C31F0D8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3A8A-D935-49BC-953D-6E3029B7432E}" type="datetimeFigureOut">
              <a:rPr lang="en-GB" smtClean="0"/>
              <a:t>27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6AC7A3-B1B4-4370-8F10-6D47D3E7C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EBA856-14F0-455E-B945-A90C9E2DE3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3F8DE-7028-41F4-BC6D-6D97ED1C3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68138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D46012-1C05-495C-A447-2B79030C2B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3B440D-6DEB-4B37-9B0F-410A30DB10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16C982-BE77-4697-830E-2A3F15A2D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3A8A-D935-49BC-953D-6E3029B7432E}" type="datetimeFigureOut">
              <a:rPr lang="en-GB" smtClean="0"/>
              <a:t>27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8E9F0C-E8D9-4458-BAE6-87B369944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B82506-9919-43A5-ABAC-A346A21C4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3F8DE-7028-41F4-BC6D-6D97ED1C3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2659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70F2547-5BB0-468E-9E3E-F8813CF6F7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583ED5-8EE9-4BFB-95A6-FD3DAAFD2E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08AD9A-666A-4926-8114-785D88EB5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3A8A-D935-49BC-953D-6E3029B7432E}" type="datetimeFigureOut">
              <a:rPr lang="en-GB" smtClean="0"/>
              <a:t>27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463F23-762B-42D6-9D48-D75C9645A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2C142E-EB13-454F-9209-2EFCCA7797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3F8DE-7028-41F4-BC6D-6D97ED1C3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9016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64A564-76B3-4381-9490-6E8E932E71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3950BE-A349-4532-962E-0F08DF0509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97259F-61A0-4BF4-890D-96889150A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3A8A-D935-49BC-953D-6E3029B7432E}" type="datetimeFigureOut">
              <a:rPr lang="en-GB" smtClean="0"/>
              <a:t>27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DA2528-B05F-4504-963B-248A5E336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4CAA28-B77B-4706-9384-CCDAC24D3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3F8DE-7028-41F4-BC6D-6D97ED1C3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8127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1D92EB-AE07-4AD8-A496-3BF69EF08F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D64E5B-90D4-4CE3-BC15-6AE0608B04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895A05-9573-4598-BAE2-A1FA838AFE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3A8A-D935-49BC-953D-6E3029B7432E}" type="datetimeFigureOut">
              <a:rPr lang="en-GB" smtClean="0"/>
              <a:t>27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C14451-77E6-4497-ABF1-E9EED7610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0ED730-3F3D-4D6A-A949-5BBA2F364A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3F8DE-7028-41F4-BC6D-6D97ED1C3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6480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9F0239-CC37-4CAD-A99D-47526768DF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561037-7BC7-420A-8678-9A100F30B8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E71929-9829-430A-A2E8-0196BC86CA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FACA31-2B6B-4785-9D7C-13F4B2D80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3A8A-D935-49BC-953D-6E3029B7432E}" type="datetimeFigureOut">
              <a:rPr lang="en-GB" smtClean="0"/>
              <a:t>27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A6D2D0-CCFD-438C-93BE-B86AE2FC4B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3D7232-E394-46B5-A733-C909AD296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3F8DE-7028-41F4-BC6D-6D97ED1C3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1996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6E664B-FF92-4E00-934B-6890B03E89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07D280-C430-4EE3-ABC2-7E9D24BDFE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376296-C704-4D36-AF82-7960E208B4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5DE5F92-3434-4CB5-AF5D-A2F5D440D2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384C75-5113-447C-A0A7-E3B6480747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219D82-ADD4-4C23-8BAF-F475C0719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3A8A-D935-49BC-953D-6E3029B7432E}" type="datetimeFigureOut">
              <a:rPr lang="en-GB" smtClean="0"/>
              <a:t>27/07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76596F4-62F3-4160-ADB2-3D5D16DDB2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7B259DB-00BE-4FBC-A91B-4F9AFED62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3F8DE-7028-41F4-BC6D-6D97ED1C3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8152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B9205E-E2C1-404E-B4F9-BEC5E3E47B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612C659-61A7-419C-8BC6-85024CB1B8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3A8A-D935-49BC-953D-6E3029B7432E}" type="datetimeFigureOut">
              <a:rPr lang="en-GB" smtClean="0"/>
              <a:t>27/07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89AD86F-41CC-48EB-AAF4-5FC6AD288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35C0925-EEED-4CF9-A819-EB92E859A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3F8DE-7028-41F4-BC6D-6D97ED1C3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5873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A823B0-DDB9-4FB7-B26C-0515C7CCB0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3A8A-D935-49BC-953D-6E3029B7432E}" type="datetimeFigureOut">
              <a:rPr lang="en-GB" smtClean="0"/>
              <a:t>27/07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7EA180A-44A8-4FC5-BAD0-48466118EB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7B9BFE6-0741-4E25-8CAC-7CD1AA4BFE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3F8DE-7028-41F4-BC6D-6D97ED1C3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6858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2913A1-49ED-4EA8-9C7A-FC7C494F9E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A05B6E-FF56-41DB-9AF6-2B44F4123A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4B11A1-6AA7-457C-AD00-5EDB7828B2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0F95BD-98A1-4E8E-836D-8AB9EF5F7B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3A8A-D935-49BC-953D-6E3029B7432E}" type="datetimeFigureOut">
              <a:rPr lang="en-GB" smtClean="0"/>
              <a:t>27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596378-CE83-47B6-A518-E36C7A032F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2F4DDE-184E-4ED7-AD60-97C67E79B7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3F8DE-7028-41F4-BC6D-6D97ED1C3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5016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FB2295-2157-4A44-8B79-B635FFB2F7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B7BB252-3A2D-4E2E-AEAB-10001A4B015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BF8E1E-22BB-4C63-A185-095401B7BC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A4B34A-7A52-4F52-9CCF-3F9056D1F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63A8A-D935-49BC-953D-6E3029B7432E}" type="datetimeFigureOut">
              <a:rPr lang="en-GB" smtClean="0"/>
              <a:t>27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C35561-0329-4D0C-899A-EF3BBAA47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BF696C-3EEB-4D82-BB5F-C8C3D3517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3F8DE-7028-41F4-BC6D-6D97ED1C3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0547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913E91-82A2-48BC-9A0E-E10349A897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D9F799-C22B-4F48-AB05-4790EED065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D9AD72-F1FD-407F-9D35-F6688B1AB4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D63A8A-D935-49BC-953D-6E3029B7432E}" type="datetimeFigureOut">
              <a:rPr lang="en-GB" smtClean="0"/>
              <a:t>27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392B99-F76C-45F8-A744-3DF4E589B9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6B572D-5525-462A-9435-70DB0A6193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F3F8DE-7028-41F4-BC6D-6D97ED1C3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1149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4C07B1E3-CABC-4822-9EAD-C7CEC73DC9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9217658"/>
              </p:ext>
            </p:extLst>
          </p:nvPr>
        </p:nvGraphicFramePr>
        <p:xfrm>
          <a:off x="341400" y="3627300"/>
          <a:ext cx="64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4C07B1E3-CABC-4822-9EAD-C7CEC73DC9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4221177"/>
              </p:ext>
            </p:extLst>
          </p:nvPr>
        </p:nvGraphicFramePr>
        <p:xfrm>
          <a:off x="341400" y="436425"/>
          <a:ext cx="64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733FAD9B-9AA6-0117-6F36-FB8B829B6D61}"/>
              </a:ext>
            </a:extLst>
          </p:cNvPr>
          <p:cNvSpPr txBox="1"/>
          <p:nvPr/>
        </p:nvSpPr>
        <p:spPr>
          <a:xfrm>
            <a:off x="6821400" y="436425"/>
            <a:ext cx="5224507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 2:</a:t>
            </a:r>
          </a:p>
          <a:p>
            <a:r>
              <a:rPr lang="en-GB" dirty="0">
                <a:effectLst/>
                <a:latin typeface="Arial" panose="020B0604020202020204" pitchFamily="34" charset="0"/>
              </a:rPr>
              <a:t>Number of CO events for the 175 chromosomes </a:t>
            </a:r>
          </a:p>
          <a:p>
            <a:r>
              <a:rPr lang="en-GB" dirty="0">
                <a:effectLst/>
                <a:latin typeface="Arial" panose="020B0604020202020204" pitchFamily="34" charset="0"/>
              </a:rPr>
              <a:t>of 25 Bowman M3 individuals and 25 BW230 M3 </a:t>
            </a:r>
          </a:p>
          <a:p>
            <a:r>
              <a:rPr lang="en-GB" dirty="0">
                <a:effectLst/>
                <a:latin typeface="Arial" panose="020B0604020202020204" pitchFamily="34" charset="0"/>
              </a:rPr>
              <a:t>individuals, respectively. Total number of CO </a:t>
            </a:r>
          </a:p>
          <a:p>
            <a:r>
              <a:rPr lang="en-GB" dirty="0">
                <a:effectLst/>
                <a:latin typeface="Arial" panose="020B0604020202020204" pitchFamily="34" charset="0"/>
              </a:rPr>
              <a:t>per 2% intervals along the physical map for each </a:t>
            </a:r>
          </a:p>
          <a:p>
            <a:r>
              <a:rPr lang="en-GB" dirty="0">
                <a:latin typeface="Arial" panose="020B0604020202020204" pitchFamily="34" charset="0"/>
              </a:rPr>
              <a:t>Individual chromosome.</a:t>
            </a:r>
            <a:endParaRPr lang="en-GB" dirty="0"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54884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DB5C587F-44FC-49D7-AC56-C42BC92EC50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3821071"/>
              </p:ext>
            </p:extLst>
          </p:nvPr>
        </p:nvGraphicFramePr>
        <p:xfrm>
          <a:off x="393066" y="3429000"/>
          <a:ext cx="64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4C07B1E3-CABC-4822-9EAD-C7CEC73DC9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9218884"/>
              </p:ext>
            </p:extLst>
          </p:nvPr>
        </p:nvGraphicFramePr>
        <p:xfrm>
          <a:off x="393066" y="388800"/>
          <a:ext cx="64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1866322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4C07B1E3-CABC-4822-9EAD-C7CEC73DC9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555225"/>
              </p:ext>
            </p:extLst>
          </p:nvPr>
        </p:nvGraphicFramePr>
        <p:xfrm>
          <a:off x="493800" y="444225"/>
          <a:ext cx="64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4C07B1E3-CABC-4822-9EAD-C7CEC73DC9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5443795"/>
              </p:ext>
            </p:extLst>
          </p:nvPr>
        </p:nvGraphicFramePr>
        <p:xfrm>
          <a:off x="493800" y="3846375"/>
          <a:ext cx="64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956981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8FA6C339-2B1F-4D91-868C-C359833063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2635668"/>
              </p:ext>
            </p:extLst>
          </p:nvPr>
        </p:nvGraphicFramePr>
        <p:xfrm>
          <a:off x="467823" y="366870"/>
          <a:ext cx="64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409564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</TotalTime>
  <Words>133</Words>
  <Application>Microsoft Office PowerPoint</Application>
  <PresentationFormat>Widescreen</PresentationFormat>
  <Paragraphs>2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iam Schreiber</dc:creator>
  <cp:lastModifiedBy>Miriam Schreiber</cp:lastModifiedBy>
  <cp:revision>3</cp:revision>
  <dcterms:created xsi:type="dcterms:W3CDTF">2022-05-01T14:44:43Z</dcterms:created>
  <dcterms:modified xsi:type="dcterms:W3CDTF">2022-07-27T10:28:26Z</dcterms:modified>
</cp:coreProperties>
</file>